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961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611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4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87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129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04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97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78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780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818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676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846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440252" y="5288815"/>
            <a:ext cx="86292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kern="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Supplementary Figure </a:t>
            </a:r>
            <a:r>
              <a:rPr lang="en-US" sz="1200" b="1" kern="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S1</a:t>
            </a:r>
            <a:r>
              <a:rPr lang="en-US" sz="1200" kern="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: Read </a:t>
            </a:r>
            <a:r>
              <a:rPr lang="en-US" sz="1200" kern="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counts for the combined </a:t>
            </a:r>
            <a:r>
              <a:rPr lang="en-US" sz="1200" kern="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dataset of sequences</a:t>
            </a:r>
            <a:r>
              <a:rPr lang="en-US" sz="1200" kern="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 downloaded from publicly available databases</a:t>
            </a:r>
            <a:r>
              <a:rPr lang="en-US" sz="1200" kern="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 </a:t>
            </a:r>
            <a:endParaRPr lang="en-US" sz="1200" dirty="0"/>
          </a:p>
        </p:txBody>
      </p:sp>
      <p:sp>
        <p:nvSpPr>
          <p:cNvPr id="4" name="Rectangle 3"/>
          <p:cNvSpPr/>
          <p:nvPr/>
        </p:nvSpPr>
        <p:spPr>
          <a:xfrm>
            <a:off x="2145819" y="416487"/>
            <a:ext cx="892369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kern="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Supplementary Figure S1</a:t>
            </a:r>
            <a:r>
              <a:rPr lang="en-US" sz="1400" kern="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: Combined </a:t>
            </a:r>
            <a:r>
              <a:rPr lang="en-US" sz="1400" kern="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Sequence datasets read counts obtained from </a:t>
            </a:r>
            <a:r>
              <a:rPr lang="en-US" sz="1400" kern="0" dirty="0">
                <a:latin typeface="Times New Roman" panose="02020603050405020304" pitchFamily="18" charset="0"/>
                <a:ea typeface="Arial Unicode MS" panose="020B0604020202020204" pitchFamily="34" charset="-128"/>
              </a:rPr>
              <a:t>selected forests around the </a:t>
            </a:r>
            <a:r>
              <a:rPr lang="en-US" sz="1400" kern="0" dirty="0" smtClean="0">
                <a:latin typeface="Times New Roman" panose="02020603050405020304" pitchFamily="18" charset="0"/>
                <a:ea typeface="Arial Unicode MS" panose="020B0604020202020204" pitchFamily="34" charset="-128"/>
              </a:rPr>
              <a:t>globe</a:t>
            </a:r>
            <a:endParaRPr lang="en-US" sz="14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1022" y="826309"/>
            <a:ext cx="8971553" cy="43604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8619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3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</dc:creator>
  <cp:lastModifiedBy>Anne</cp:lastModifiedBy>
  <cp:revision>21</cp:revision>
  <dcterms:created xsi:type="dcterms:W3CDTF">2022-12-12T13:17:02Z</dcterms:created>
  <dcterms:modified xsi:type="dcterms:W3CDTF">2023-04-17T09:53:27Z</dcterms:modified>
</cp:coreProperties>
</file>